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C062C7-1080-47E3-81FB-194003E9ED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E3DB26-55A0-4094-BCD3-786776A327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BFD3D4-6BDC-48D0-A290-15AD2238B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A4D8F4-1812-4A5E-8EF0-168F061D6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B59FAB-03AA-43BE-AA80-868D61BE6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384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C7817-2934-417A-BA0A-85B4A7517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017578-B47E-4D26-B094-3CCAFA1F98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C22160-0EBB-448B-8DB9-89BA9C739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4EB05C-7F27-47D5-AC7A-0DA75B9AC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B13E8-C5E7-4C0E-B835-93619C0F1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338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E0EE7C-CA3C-4C38-91B3-7ADC12A5EC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3AEE2F-9755-484F-A21E-6CEDB5DCFC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AF7A3-D258-4C4D-9EED-6FBF746A8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A8A326-B7E5-410A-8BA0-32F6327C5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BA0DC1-E823-4FA6-AD87-D8729C1FD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540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1A61E3-A2DB-4193-B48C-6E7311C15D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274C25-64A7-4AC8-B289-14302E7D9D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BBE37D-D27A-4179-848C-1E8B047CB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531B5B-52F7-40D9-B641-331203A8D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45F8B3-9A8D-475B-A93C-6F68ACE93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475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D963A-4585-40F9-AC55-D469386E6F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2151B5-B4ED-49C0-9103-3A2FF105D6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5514F7-0C39-4C48-A7C9-5D9B969BF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C82B5C-7089-48B9-938B-7E161C5FE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A62D21-0786-4431-ABE6-08219F42B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79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BB613-21F2-4170-A69E-2E1804CC7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8FC47A-6E11-4FB4-AA37-5415086D31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5CF5EB-868B-403B-8C64-F1BD4FBF8C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99698-0786-4E5E-90C9-F8C27B67D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816914-7B88-47BD-A0C0-200ABB114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6DE218-CA27-41BD-BDDB-7F300AE8B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505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72E1B-6212-4DF4-A95E-F6EF92766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EB40E6-FEC3-4C56-BFC1-A45A0B33B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F71DDE-FE1B-4C45-97F0-5FF27C0C0B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B11EE0-C7B1-4372-BA59-71A0642CC7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D3D773-0183-4431-8160-968E34D551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FBF65A-7222-4581-A336-F69AA0881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C7DF3F-FFA2-493E-BC1B-AFE503BF9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F9D63F-8139-4B39-B383-5D5FC0A4C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559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C04AB-03DD-4BC0-BBCF-B65F20CDC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CF12E9-72EA-4368-99B7-C5E48F059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73B659-3805-4E13-93EB-4F02C2178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F9F5E4-8EB7-45F4-B7C7-79070BF79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225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3EAFC5-8F74-4988-93EE-1087B9252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91E4AA6-8A52-48FC-B5F5-661EE297F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BE0BDB-3BA5-49DB-978B-2986E0874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411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FDDB75-2F2C-4BAF-95E2-BA4BC2F72A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36285B-C24D-4CC1-B290-640048A411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660139-C16F-4AF4-9918-43F4A20787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881026-14D3-425F-A502-2F8F33134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F235EF-EB2A-4F0C-83EF-AC81CB42E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F49988-7ADE-45EB-B07A-BEF9566FE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008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D77C3-BB75-4585-A2F2-23B7A881C2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7B6D70-C70B-406B-ACC6-2CF671C000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052B4C-0CE8-4B1E-B860-D03A69AAF0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E4F771-3237-4FC7-ABBD-B5202EAF4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DE4003-006E-4EA3-8869-3AA36FADD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0B5C40-5D69-447D-97BD-2BE4B5DBF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387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CF8BD9-A147-4E22-8D90-B122490FF1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69BDCE-CF87-40BB-9761-542FE4A2AE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AF110-2475-42D3-A0C3-FE391477D0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A6E07-F785-4E3F-A6CE-8AA1BB35EA50}" type="datetimeFigureOut">
              <a:rPr lang="en-US" smtClean="0"/>
              <a:t>2019-11-2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097327-5963-4871-8EE3-84EC73C224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26722-BC94-49DD-8CAC-8FF99A7123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69B56-99B8-43ED-AF28-BAAC30BC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809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6C07B65-ECA0-4D48-890B-977EAC44F7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487" y="868524"/>
            <a:ext cx="2867025" cy="57245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59FD185-000E-4B55-A462-2B6DF143DD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6466" y="868524"/>
            <a:ext cx="2867025" cy="20193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8C7BF0E-CC1A-477D-B5BE-8BC9D77989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22445" y="800099"/>
            <a:ext cx="2914650" cy="60293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924691D-8ED7-4C48-A9C2-04B9A9F603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51689" y="800099"/>
            <a:ext cx="2857500" cy="14382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0784BED-942D-49B0-AEE9-2E3E06DBCA91}"/>
              </a:ext>
            </a:extLst>
          </p:cNvPr>
          <p:cNvSpPr txBox="1"/>
          <p:nvPr/>
        </p:nvSpPr>
        <p:spPr>
          <a:xfrm>
            <a:off x="242596" y="279918"/>
            <a:ext cx="1727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ID-ETD settings</a:t>
            </a:r>
          </a:p>
        </p:txBody>
      </p:sp>
    </p:spTree>
    <p:extLst>
      <p:ext uri="{BB962C8B-B14F-4D97-AF65-F5344CB8AC3E}">
        <p14:creationId xmlns:p14="http://schemas.microsoft.com/office/powerpoint/2010/main" val="3895331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0042DD0-7ECF-4C5D-A5F9-BED80F62BF8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8476"/>
          <a:stretch/>
        </p:blipFill>
        <p:spPr>
          <a:xfrm>
            <a:off x="135371" y="904876"/>
            <a:ext cx="2887747" cy="557057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C0F3F9A-007A-4E9D-B03F-2269EB1A4B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0564"/>
          <a:stretch/>
        </p:blipFill>
        <p:spPr>
          <a:xfrm>
            <a:off x="3274137" y="904876"/>
            <a:ext cx="2821863" cy="21487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C0DEDB9-6374-4A00-BB79-C631B6A39F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47019" y="904876"/>
            <a:ext cx="3144397" cy="575873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B08CB36-0DD8-43C8-A589-A0127CD9510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9406"/>
          <a:stretch/>
        </p:blipFill>
        <p:spPr>
          <a:xfrm>
            <a:off x="9635964" y="904876"/>
            <a:ext cx="2420665" cy="12001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703E0E8-AB9A-4B87-9113-BBB840339D71}"/>
              </a:ext>
            </a:extLst>
          </p:cNvPr>
          <p:cNvSpPr txBox="1"/>
          <p:nvPr/>
        </p:nvSpPr>
        <p:spPr>
          <a:xfrm>
            <a:off x="135371" y="197888"/>
            <a:ext cx="1876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2-MS3 settings</a:t>
            </a:r>
          </a:p>
        </p:txBody>
      </p:sp>
    </p:spTree>
    <p:extLst>
      <p:ext uri="{BB962C8B-B14F-4D97-AF65-F5344CB8AC3E}">
        <p14:creationId xmlns:p14="http://schemas.microsoft.com/office/powerpoint/2010/main" val="26066214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55055E-5CF3-453D-8890-E9FB70CD09B5}"/>
              </a:ext>
            </a:extLst>
          </p:cNvPr>
          <p:cNvSpPr txBox="1"/>
          <p:nvPr/>
        </p:nvSpPr>
        <p:spPr>
          <a:xfrm>
            <a:off x="135371" y="197888"/>
            <a:ext cx="20529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3-EtHCD setting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EB93729-C9BC-4C55-A715-5708356618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371" y="847200"/>
            <a:ext cx="3152775" cy="57340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A511B9C-56D7-43D1-9556-A94F8BBB99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2416"/>
          <a:stretch/>
        </p:blipFill>
        <p:spPr>
          <a:xfrm>
            <a:off x="3369999" y="847200"/>
            <a:ext cx="2928160" cy="19907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39B384D-37D0-4E53-B1C0-BFAC3BBD86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45337" y="847200"/>
            <a:ext cx="3038475" cy="60102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99A14D1-2D2C-44A6-B770-19F03F774C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80154" y="857172"/>
            <a:ext cx="2276475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7270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42FA6AA-7076-40E4-9470-568D4321D3CE}"/>
              </a:ext>
            </a:extLst>
          </p:cNvPr>
          <p:cNvSpPr txBox="1"/>
          <p:nvPr/>
        </p:nvSpPr>
        <p:spPr>
          <a:xfrm>
            <a:off x="135371" y="197888"/>
            <a:ext cx="1779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2-CID setting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B1C1E7-76BE-4F3D-A3FA-2A8FEE0F48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131" y="782657"/>
            <a:ext cx="2847975" cy="57340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C179628-4A7E-42B5-9083-E4DF188030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255" y="782657"/>
            <a:ext cx="2628900" cy="1905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1E39407-FA2A-4C2D-9B32-77B90410F2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782657"/>
            <a:ext cx="3019425" cy="59721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DD450DA-456F-4D7D-9CEF-45992C2065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25031" y="780560"/>
            <a:ext cx="2133600" cy="87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84632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5F7BCD-6525-4359-B0D9-92914DFFEE51}"/>
              </a:ext>
            </a:extLst>
          </p:cNvPr>
          <p:cNvSpPr txBox="1"/>
          <p:nvPr/>
        </p:nvSpPr>
        <p:spPr>
          <a:xfrm>
            <a:off x="135371" y="197888"/>
            <a:ext cx="2013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2 </a:t>
            </a:r>
            <a:r>
              <a:rPr lang="en-US" dirty="0" err="1"/>
              <a:t>stHCD</a:t>
            </a:r>
            <a:r>
              <a:rPr lang="en-US" dirty="0"/>
              <a:t> setting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4199B83-D8F0-4F75-90C6-B4ABB9C1E6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371" y="693708"/>
            <a:ext cx="2686050" cy="570547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E067D1E-F27F-46ED-9DF7-3A58EDDABD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3411" y="693708"/>
            <a:ext cx="2590800" cy="19335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8186391-69DA-4A1E-BF84-5C34D89101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70708" y="721103"/>
            <a:ext cx="3133725" cy="6019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B98C5CF-F8CE-48A9-817D-80ACC0B178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28589" y="693708"/>
            <a:ext cx="1752600" cy="866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1563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A6CC5E1-EDFA-4587-BFF9-007B37E29612}"/>
              </a:ext>
            </a:extLst>
          </p:cNvPr>
          <p:cNvSpPr txBox="1"/>
          <p:nvPr/>
        </p:nvSpPr>
        <p:spPr>
          <a:xfrm>
            <a:off x="135371" y="197888"/>
            <a:ext cx="3548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2 Q-</a:t>
            </a:r>
            <a:r>
              <a:rPr lang="en-US" dirty="0" err="1"/>
              <a:t>exactive</a:t>
            </a:r>
            <a:r>
              <a:rPr lang="en-US" dirty="0"/>
              <a:t> HFX settings (DSSO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77FB96C-389C-4B1B-8ED2-B16C1B0ABE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113" y="794656"/>
            <a:ext cx="2533650" cy="57721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A528CE4-6BF0-4619-B2A2-65DF8E854C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83395" y="794656"/>
            <a:ext cx="2400300" cy="19716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518F0A0-F4A9-484B-8EB2-A0DE3D2C2B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15327" y="794656"/>
            <a:ext cx="2638425" cy="6019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8159B6C-011B-48A7-BFC9-E6BD60E893D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58949" y="794656"/>
            <a:ext cx="1638300" cy="857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2364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0D5183-F854-43F9-8A5F-8A24CA91844F}"/>
              </a:ext>
            </a:extLst>
          </p:cNvPr>
          <p:cNvSpPr txBox="1"/>
          <p:nvPr/>
        </p:nvSpPr>
        <p:spPr>
          <a:xfrm>
            <a:off x="135371" y="197888"/>
            <a:ext cx="35629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2 Q-</a:t>
            </a:r>
            <a:r>
              <a:rPr lang="en-US" dirty="0" err="1"/>
              <a:t>exactive</a:t>
            </a:r>
            <a:r>
              <a:rPr lang="en-US" dirty="0"/>
              <a:t> HFX settings (DSBU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652CEDD-BBF2-4795-A5C2-03F656524E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9768" y="876203"/>
            <a:ext cx="2400300" cy="19145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5F4B193-EA45-408B-8875-449E73BF73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074" y="876203"/>
            <a:ext cx="2543175" cy="572452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47DFD9A-D9AF-4E10-8924-7363501C98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58361" y="704752"/>
            <a:ext cx="2714625" cy="606742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66B2ED0-0BC0-417B-A988-1155145037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22592" y="704752"/>
            <a:ext cx="1885950" cy="885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129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Widescreen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:sp. protein,protein</dc:creator>
  <cp:lastModifiedBy>:sp. protein,protein</cp:lastModifiedBy>
  <cp:revision>6</cp:revision>
  <dcterms:created xsi:type="dcterms:W3CDTF">2019-11-28T10:04:28Z</dcterms:created>
  <dcterms:modified xsi:type="dcterms:W3CDTF">2019-11-28T12:50:05Z</dcterms:modified>
</cp:coreProperties>
</file>